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13716000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2" d="100"/>
          <a:sy n="42" d="100"/>
        </p:scale>
        <p:origin x="14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1795781"/>
            <a:ext cx="11658600" cy="3820160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5763261"/>
            <a:ext cx="10287000" cy="2649219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446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134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584200"/>
            <a:ext cx="2957513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584200"/>
            <a:ext cx="8701088" cy="92989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39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418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2735583"/>
            <a:ext cx="11830050" cy="4564379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7343143"/>
            <a:ext cx="11830050" cy="2400299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78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2921000"/>
            <a:ext cx="582930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2921000"/>
            <a:ext cx="582930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147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584202"/>
            <a:ext cx="11830050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2689861"/>
            <a:ext cx="5802510" cy="1318259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4008120"/>
            <a:ext cx="5802510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2689861"/>
            <a:ext cx="5831087" cy="1318259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4008120"/>
            <a:ext cx="5831087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760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927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946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31520"/>
            <a:ext cx="4423767" cy="256032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579882"/>
            <a:ext cx="6943725" cy="7797800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291840"/>
            <a:ext cx="4423767" cy="6098541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404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31520"/>
            <a:ext cx="4423767" cy="256032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579882"/>
            <a:ext cx="6943725" cy="7797800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291840"/>
            <a:ext cx="4423767" cy="6098541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427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584202"/>
            <a:ext cx="1183005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2921000"/>
            <a:ext cx="1183005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0170162"/>
            <a:ext cx="30861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D021E-9E57-431E-A35B-9645663E736E}" type="datetimeFigureOut">
              <a:rPr lang="en-US" smtClean="0"/>
              <a:t>4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0170162"/>
            <a:ext cx="46291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0170162"/>
            <a:ext cx="30861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1271F-4F4C-4402-A762-7E9B075FF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370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5A0803BB-C1F4-46EE-BEB6-1DEA26CA8887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796" y="581165"/>
            <a:ext cx="3291840" cy="393192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51A1C688-2B34-47AB-8776-FE219CE62103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9136" y="4631571"/>
            <a:ext cx="6583680" cy="41148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5A83AB9-166C-409C-817F-EE749E77D312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9136" y="581165"/>
            <a:ext cx="6583680" cy="393192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1117A9E5-58A1-464C-BE99-455D5D65B1E0}"/>
              </a:ext>
            </a:extLst>
          </p:cNvPr>
          <p:cNvSpPr txBox="1"/>
          <p:nvPr/>
        </p:nvSpPr>
        <p:spPr>
          <a:xfrm>
            <a:off x="3197507" y="45720"/>
            <a:ext cx="70775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This is an animation. View in Slide Show mode. 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67A4AA12-D4E2-4E91-945B-06E8A1CED334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3636" y="581165"/>
            <a:ext cx="3291840" cy="393192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05FECBB2-19AA-45FF-99BB-0B2BD7C7F2A5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184" y="4631571"/>
            <a:ext cx="6583680" cy="41148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3EC6D608-BB79-4C18-ADF0-5D1AB4E2F9FB}"/>
              </a:ext>
            </a:extLst>
          </p:cNvPr>
          <p:cNvSpPr txBox="1"/>
          <p:nvPr/>
        </p:nvSpPr>
        <p:spPr>
          <a:xfrm>
            <a:off x="11590615" y="4143753"/>
            <a:ext cx="1952201" cy="369332"/>
          </a:xfrm>
          <a:prstGeom prst="rect">
            <a:avLst/>
          </a:prstGeom>
          <a:solidFill>
            <a:schemeClr val="accent2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TA dynamics curv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FB54C75-5AAB-4091-AEFD-B81D5B714D11}"/>
              </a:ext>
            </a:extLst>
          </p:cNvPr>
          <p:cNvSpPr txBox="1"/>
          <p:nvPr/>
        </p:nvSpPr>
        <p:spPr>
          <a:xfrm>
            <a:off x="173184" y="8377039"/>
            <a:ext cx="2317983" cy="369332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RV strain and SR curv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943B36D-E9A1-482D-AF1C-AC9FEC2C6B9C}"/>
              </a:ext>
            </a:extLst>
          </p:cNvPr>
          <p:cNvSpPr txBox="1"/>
          <p:nvPr/>
        </p:nvSpPr>
        <p:spPr>
          <a:xfrm>
            <a:off x="171796" y="4143753"/>
            <a:ext cx="1237284" cy="369332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TA trackin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1BAA0A0-D8DD-416D-A55E-93BADF97CF6E}"/>
              </a:ext>
            </a:extLst>
          </p:cNvPr>
          <p:cNvSpPr txBox="1"/>
          <p:nvPr/>
        </p:nvSpPr>
        <p:spPr>
          <a:xfrm>
            <a:off x="3934691" y="4143753"/>
            <a:ext cx="2820785" cy="369332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RV and RA strain derivatio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FCC6411-61A4-4B8D-8308-2856CCB18F59}"/>
              </a:ext>
            </a:extLst>
          </p:cNvPr>
          <p:cNvSpPr txBox="1"/>
          <p:nvPr/>
        </p:nvSpPr>
        <p:spPr>
          <a:xfrm>
            <a:off x="6959136" y="8377039"/>
            <a:ext cx="2317983" cy="369332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RA strain and SR curv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CBE47CA-7A51-448F-8C1D-2B3A829E53B3}"/>
              </a:ext>
            </a:extLst>
          </p:cNvPr>
          <p:cNvSpPr txBox="1"/>
          <p:nvPr/>
        </p:nvSpPr>
        <p:spPr>
          <a:xfrm>
            <a:off x="171796" y="8864857"/>
            <a:ext cx="13371020" cy="19389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/>
              <a:t>Top left</a:t>
            </a:r>
            <a:r>
              <a:rPr lang="en-US" sz="2000" dirty="0"/>
              <a:t>: Tricuspid annular (TA) tracking and derivation of right ventricular (RV) and right atrial (RA) strain from time-varying distances between either the medial or the lateral tricuspid valve insertion and the RV apex or RA roof point; </a:t>
            </a:r>
            <a:r>
              <a:rPr lang="en-US" sz="2000" b="1" dirty="0"/>
              <a:t>Top right</a:t>
            </a:r>
            <a:r>
              <a:rPr lang="en-US" sz="2000" dirty="0"/>
              <a:t>: TA velocity and displacement curves. Peak TA velocities are read off velocity curve during systole (S’), early diastole (E’), late diastole (A’); TA plane systolic excursion (TAPSE) is read off displacement curve at end-systole; </a:t>
            </a:r>
            <a:r>
              <a:rPr lang="en-US" sz="2000" b="1" dirty="0"/>
              <a:t>Bottom left</a:t>
            </a:r>
            <a:r>
              <a:rPr lang="en-US" sz="2000" dirty="0"/>
              <a:t>: RV strain and strain rate (SR) curves, from which RV global longitudinal strain and strain rate measurements are extracted. </a:t>
            </a:r>
            <a:r>
              <a:rPr lang="en-US" sz="2000" b="1" dirty="0"/>
              <a:t>Bottom right</a:t>
            </a:r>
            <a:r>
              <a:rPr lang="en-US" sz="2000" dirty="0"/>
              <a:t>: RA strain and SR curves, from which RA phasic longitudinal strain and strain rate measurements are extracted. Details see text. </a:t>
            </a:r>
          </a:p>
        </p:txBody>
      </p:sp>
    </p:spTree>
    <p:extLst>
      <p:ext uri="{BB962C8B-B14F-4D97-AF65-F5344CB8AC3E}">
        <p14:creationId xmlns:p14="http://schemas.microsoft.com/office/powerpoint/2010/main" val="3178392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176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Leng Shuang</cp:lastModifiedBy>
  <cp:revision>6</cp:revision>
  <dcterms:created xsi:type="dcterms:W3CDTF">2021-04-09T07:16:23Z</dcterms:created>
  <dcterms:modified xsi:type="dcterms:W3CDTF">2021-04-15T09:38:15Z</dcterms:modified>
</cp:coreProperties>
</file>